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6"/>
  </p:notesMasterIdLst>
  <p:sldIdLst>
    <p:sldId id="272" r:id="rId2"/>
    <p:sldId id="260" r:id="rId3"/>
    <p:sldId id="264" r:id="rId4"/>
    <p:sldId id="273" r:id="rId5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CC"/>
    <a:srgbClr val="0000FF"/>
    <a:srgbClr val="FF9900"/>
    <a:srgbClr val="FF0000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3414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B58F22A7-131E-458F-A98D-39EA7C873D05}" type="datetimeFigureOut">
              <a:rPr lang="en-GB" smtClean="0"/>
              <a:t>18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2500" y="768350"/>
            <a:ext cx="26543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BD98349E-1EAA-430C-B8F5-D1CE7B1E5F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7641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5F423-10A7-48AC-88E8-93D305982EC7}" type="datetime1">
              <a:rPr lang="en-GB" smtClean="0"/>
              <a:t>1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37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3ED18-1641-4DB4-93E8-77D3EC2F8046}" type="datetime1">
              <a:rPr lang="en-GB" smtClean="0"/>
              <a:t>1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887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4EF6-5232-48C9-B815-0F384AA6A50F}" type="datetime1">
              <a:rPr lang="en-GB" smtClean="0"/>
              <a:t>1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612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3E4F4-57FE-4EA2-A35F-165349DBD2BF}" type="datetime1">
              <a:rPr lang="en-GB" smtClean="0"/>
              <a:t>1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004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7848A-EE9F-400D-BEF4-DB889454CFE2}" type="datetime1">
              <a:rPr lang="en-GB" smtClean="0"/>
              <a:t>1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53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2277-AB46-41F1-9876-327D470D2039}" type="datetime1">
              <a:rPr lang="en-GB" smtClean="0"/>
              <a:t>18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347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2CA3-173C-49B2-91D5-1E4A9020DBCF}" type="datetime1">
              <a:rPr lang="en-GB" smtClean="0"/>
              <a:t>18/07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096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B3913-09E0-481A-BC09-61DC77702212}" type="datetime1">
              <a:rPr lang="en-GB" smtClean="0"/>
              <a:t>18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04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676B-3E9C-4A54-8202-28F0206ED78F}" type="datetime1">
              <a:rPr lang="en-GB" smtClean="0"/>
              <a:t>18/07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121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FFF-764F-46D1-9363-F070A8D56024}" type="datetime1">
              <a:rPr lang="en-GB" smtClean="0"/>
              <a:t>18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57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2DCEF-7E52-4E8F-B9E2-C7840E0B31E2}" type="datetime1">
              <a:rPr lang="en-GB" smtClean="0"/>
              <a:t>18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34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776EA-4B72-4581-B850-2AB2C42BE536}" type="datetime1">
              <a:rPr lang="en-GB" smtClean="0"/>
              <a:t>1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132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131121" y="992560"/>
            <a:ext cx="6587669" cy="4481742"/>
            <a:chOff x="80908" y="2847522"/>
            <a:chExt cx="6587669" cy="4481742"/>
          </a:xfrm>
        </p:grpSpPr>
        <p:pic>
          <p:nvPicPr>
            <p:cNvPr id="5" name="Picture 4" descr="G:\Rifat 14C Expts\PAGE prelim expt\R+B s2 Gel AutoRad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32656" y="5385048"/>
              <a:ext cx="2700000" cy="19442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" descr="G:\Rifat 14C Expts\PAGE prelim expt\PAGE+Silver Stain_ R+B s1_top &amp; s2_bottom-tilted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32656" y="3409768"/>
              <a:ext cx="2700000" cy="19442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3" descr="G:\Rifat 14C Expts\PAGE prelim expt\A+B s2 Gel AutoRad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202208" y="5385048"/>
              <a:ext cx="2998800" cy="19442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4" descr="G:\Rifat 14C Expts\PAGE prelim expt\PAGE+Silver Stain_ A + B s1_top &amp; s2_bottom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 flipH="1">
              <a:off x="3202208" y="3409768"/>
              <a:ext cx="2998800" cy="19442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6226148" y="4207800"/>
              <a:ext cx="26289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di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226148" y="4701984"/>
              <a:ext cx="44242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mono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75972" y="3193744"/>
              <a:ext cx="105799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M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04905" y="3193744"/>
              <a:ext cx="246863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0.2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45834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1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341486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3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621898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5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902310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8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167313" y="3193744"/>
              <a:ext cx="202363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11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450728" y="3193744"/>
              <a:ext cx="211596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14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806898" y="3193744"/>
              <a:ext cx="105799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M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31098" y="2847522"/>
              <a:ext cx="153086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i="1" smtClean="0">
                  <a:latin typeface="Arial Narrow" panose="020B0606020202030204" pitchFamily="34" charset="0"/>
                  <a:cs typeface="Arial" pitchFamily="34" charset="0"/>
                </a:rPr>
                <a:t>Rosa</a:t>
              </a:r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 (age after subculture)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5" name="AutoShape 4"/>
            <p:cNvSpPr>
              <a:spLocks/>
            </p:cNvSpPr>
            <p:nvPr/>
          </p:nvSpPr>
          <p:spPr bwMode="auto">
            <a:xfrm rot="16200000" flipH="1">
              <a:off x="1604688" y="2107605"/>
              <a:ext cx="183689" cy="2016224"/>
            </a:xfrm>
            <a:prstGeom prst="leftBrace">
              <a:avLst>
                <a:gd name="adj1" fmla="val 97619"/>
                <a:gd name="adj2" fmla="val 50000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721271" y="2848981"/>
              <a:ext cx="1965282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i="1" smtClean="0">
                  <a:latin typeface="Arial Narrow" panose="020B0606020202030204" pitchFamily="34" charset="0"/>
                  <a:cs typeface="Arial" pitchFamily="34" charset="0"/>
                </a:rPr>
                <a:t>Arabidopsis</a:t>
              </a:r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 (age after subculture)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7" name="AutoShape 4"/>
            <p:cNvSpPr>
              <a:spLocks/>
            </p:cNvSpPr>
            <p:nvPr/>
          </p:nvSpPr>
          <p:spPr bwMode="auto">
            <a:xfrm rot="16200000" flipH="1">
              <a:off x="4612068" y="1965048"/>
              <a:ext cx="183689" cy="2304257"/>
            </a:xfrm>
            <a:prstGeom prst="leftBrace">
              <a:avLst>
                <a:gd name="adj1" fmla="val 97619"/>
                <a:gd name="adj2" fmla="val 50000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347816" y="3193744"/>
              <a:ext cx="105799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M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576749" y="3193744"/>
              <a:ext cx="246863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0.2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917678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1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506683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3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87095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>
                  <a:latin typeface="Arial Narrow" panose="020B0606020202030204" pitchFamily="34" charset="0"/>
                  <a:cs typeface="Arial" pitchFamily="34" charset="0"/>
                </a:rPr>
                <a:t>4</a:t>
              </a:r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067507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>
                  <a:latin typeface="Arial Narrow" panose="020B0606020202030204" pitchFamily="34" charset="0"/>
                  <a:cs typeface="Arial" pitchFamily="34" charset="0"/>
                </a:rPr>
                <a:t>5</a:t>
              </a:r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363159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>
                  <a:latin typeface="Arial Narrow" panose="020B0606020202030204" pitchFamily="34" charset="0"/>
                  <a:cs typeface="Arial" pitchFamily="34" charset="0"/>
                </a:rPr>
                <a:t>7</a:t>
              </a:r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615925" y="3193744"/>
              <a:ext cx="211596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14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956803" y="3193744"/>
              <a:ext cx="105799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M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194879" y="3193744"/>
              <a:ext cx="14106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200">
                  <a:latin typeface="Arial Narrow" panose="020B0606020202030204" pitchFamily="34" charset="0"/>
                  <a:cs typeface="Arial" pitchFamily="34" charset="0"/>
                </a:rPr>
                <a:t>2</a:t>
              </a:r>
              <a:r>
                <a:rPr lang="en-GB" sz="1200" smtClean="0">
                  <a:latin typeface="Arial Narrow" panose="020B0606020202030204" pitchFamily="34" charset="0"/>
                  <a:cs typeface="Arial" pitchFamily="34" charset="0"/>
                </a:rPr>
                <a:t>d</a:t>
              </a:r>
              <a:endParaRPr lang="en-GB" sz="12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226148" y="6321152"/>
              <a:ext cx="26289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di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226148" y="6815336"/>
              <a:ext cx="44242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mono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12299" y="5269532"/>
              <a:ext cx="352661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400" b="1" smtClean="0">
                  <a:latin typeface="Arial Narrow" panose="020B0606020202030204" pitchFamily="34" charset="0"/>
                  <a:cs typeface="Arial" pitchFamily="34" charset="0"/>
                </a:rPr>
                <a:t>Set 2</a:t>
              </a:r>
              <a:endParaRPr lang="en-GB" sz="1400" b="1">
                <a:latin typeface="Arial Narrow" panose="020B0606020202030204" pitchFamily="34" charset="0"/>
                <a:cs typeface="Arial" pitchFamily="34" charset="0"/>
              </a:endParaRPr>
            </a:p>
          </p:txBody>
        </p:sp>
      </p:grpSp>
      <p:sp>
        <p:nvSpPr>
          <p:cNvPr id="7" name="Rectangle 6"/>
          <p:cNvSpPr/>
          <p:nvPr/>
        </p:nvSpPr>
        <p:spPr>
          <a:xfrm>
            <a:off x="1714500" y="5961112"/>
            <a:ext cx="3429000" cy="123110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 b="1">
                <a:ea typeface="Calibri"/>
                <a:cs typeface="Vrinda"/>
              </a:rPr>
              <a:t>Fig. S1:</a:t>
            </a:r>
            <a:r>
              <a:rPr lang="en-GB" sz="1200">
                <a:ea typeface="Calibri"/>
                <a:cs typeface="Vrinda"/>
              </a:rPr>
              <a:t> </a:t>
            </a:r>
            <a:r>
              <a:rPr lang="en-GB" sz="1200" b="1" baseline="30000">
                <a:ea typeface="Calibri"/>
                <a:cs typeface="Vrinda"/>
              </a:rPr>
              <a:t>14</a:t>
            </a:r>
            <a:r>
              <a:rPr lang="en-GB" sz="1200" b="1">
                <a:ea typeface="Calibri"/>
                <a:cs typeface="Vrinda"/>
              </a:rPr>
              <a:t>C-Labelling of RG-II by differently aged cultures.</a:t>
            </a:r>
            <a:endParaRPr lang="en-GB" sz="1200">
              <a:latin typeface="Calibri"/>
              <a:ea typeface="Calibri"/>
              <a:cs typeface="Vrinda"/>
            </a:endParaRPr>
          </a:p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>
                <a:ea typeface="Calibri"/>
                <a:cs typeface="Vrinda"/>
              </a:rPr>
              <a:t>A repeat of the experiment shown in Fig. 2. These mini-cultures (‘set 2’) were taken from independent standard cultures.</a:t>
            </a:r>
            <a:endParaRPr lang="en-GB" sz="1200">
              <a:effectLst/>
              <a:latin typeface="Calibri"/>
              <a:ea typeface="Calibri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1055203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>
            <a:grpSpLocks noChangeAspect="1"/>
          </p:cNvGrpSpPr>
          <p:nvPr/>
        </p:nvGrpSpPr>
        <p:grpSpPr>
          <a:xfrm>
            <a:off x="723606" y="1136576"/>
            <a:ext cx="5392268" cy="3182285"/>
            <a:chOff x="548680" y="1136576"/>
            <a:chExt cx="5392268" cy="3182285"/>
          </a:xfrm>
        </p:grpSpPr>
        <p:grpSp>
          <p:nvGrpSpPr>
            <p:cNvPr id="6" name="Group 5"/>
            <p:cNvGrpSpPr>
              <a:grpSpLocks noChangeAspect="1"/>
            </p:cNvGrpSpPr>
            <p:nvPr/>
          </p:nvGrpSpPr>
          <p:grpSpPr>
            <a:xfrm>
              <a:off x="548680" y="1136576"/>
              <a:ext cx="5392268" cy="3182285"/>
              <a:chOff x="548680" y="1136576"/>
              <a:chExt cx="5392268" cy="3182285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48680" y="1136576"/>
                <a:ext cx="5392268" cy="3182285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124744" y="1208584"/>
                <a:ext cx="7729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r>
                  <a:rPr lang="en-GB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200" i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Rosa</a:t>
                </a:r>
                <a:endParaRPr lang="en-GB" sz="12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679919" y="1208584"/>
                <a:ext cx="12165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r>
                  <a:rPr lang="en-GB" sz="1200">
                    <a:latin typeface="Arial" panose="020B0604020202020204" pitchFamily="34" charset="0"/>
                    <a:cs typeface="Arial" panose="020B0604020202020204" pitchFamily="34" charset="0"/>
                  </a:rPr>
                  <a:t> A</a:t>
                </a:r>
                <a:r>
                  <a:rPr lang="en-GB" sz="1200" smtClean="0">
                    <a:latin typeface="Arial" panose="020B0604020202020204" pitchFamily="34" charset="0"/>
                    <a:cs typeface="Arial" panose="020B0604020202020204" pitchFamily="34" charset="0"/>
                  </a:rPr>
                  <a:t>rabidopsis</a:t>
                </a:r>
                <a:endParaRPr lang="en-GB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9" name="Straight Connector 18"/>
            <p:cNvCxnSpPr/>
            <p:nvPr/>
          </p:nvCxnSpPr>
          <p:spPr>
            <a:xfrm>
              <a:off x="1760911" y="2360712"/>
              <a:ext cx="194400" cy="0"/>
            </a:xfrm>
            <a:prstGeom prst="line">
              <a:avLst/>
            </a:prstGeom>
            <a:ln w="28575">
              <a:solidFill>
                <a:srgbClr val="CC00C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269060" y="2360712"/>
              <a:ext cx="194400" cy="0"/>
            </a:xfrm>
            <a:prstGeom prst="line">
              <a:avLst/>
            </a:prstGeom>
            <a:ln w="28575">
              <a:solidFill>
                <a:srgbClr val="CC00CC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 rot="16200000">
              <a:off x="1553856" y="1983693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smtClean="0">
                  <a:solidFill>
                    <a:srgbClr val="CC00CC"/>
                  </a:solidFill>
                  <a:latin typeface="Arial Narrow" panose="020B0606020202030204" pitchFamily="34" charset="0"/>
                </a:rPr>
                <a:t>Glucose</a:t>
              </a:r>
              <a:endParaRPr lang="en-GB" sz="1100">
                <a:solidFill>
                  <a:srgbClr val="CC00CC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4040269" y="1983693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smtClean="0">
                  <a:solidFill>
                    <a:srgbClr val="CC00CC"/>
                  </a:solidFill>
                  <a:latin typeface="Arial Narrow" panose="020B0606020202030204" pitchFamily="34" charset="0"/>
                </a:rPr>
                <a:t>Glucose</a:t>
              </a:r>
              <a:endParaRPr lang="en-GB" sz="1100">
                <a:solidFill>
                  <a:srgbClr val="CC00CC"/>
                </a:solidFill>
                <a:latin typeface="Arial Narrow" panose="020B0606020202030204" pitchFamily="34" charset="0"/>
              </a:endParaRPr>
            </a:p>
          </p:txBody>
        </p:sp>
      </p:grpSp>
      <p:sp>
        <p:nvSpPr>
          <p:cNvPr id="8" name="Rectangle 7"/>
          <p:cNvSpPr/>
          <p:nvPr/>
        </p:nvSpPr>
        <p:spPr>
          <a:xfrm>
            <a:off x="1714500" y="4953000"/>
            <a:ext cx="3429000" cy="334110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 b="1">
                <a:ea typeface="Calibri"/>
                <a:cs typeface="Vrinda"/>
              </a:rPr>
              <a:t>Fig. S2: [</a:t>
            </a:r>
            <a:r>
              <a:rPr lang="en-GB" sz="1200" b="1" baseline="30000">
                <a:ea typeface="Calibri"/>
                <a:cs typeface="Vrinda"/>
              </a:rPr>
              <a:t>14</a:t>
            </a:r>
            <a:r>
              <a:rPr lang="en-GB" sz="1200" b="1">
                <a:ea typeface="Calibri"/>
                <a:cs typeface="Vrinda"/>
              </a:rPr>
              <a:t>C]Glucose is removed from the culture medium accompanied by release of traces of extracellular radioactive metabolites. </a:t>
            </a:r>
            <a:endParaRPr lang="en-GB" sz="1200">
              <a:latin typeface="Calibri"/>
              <a:ea typeface="Calibri"/>
              <a:cs typeface="Vrinda"/>
            </a:endParaRPr>
          </a:p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>
                <a:ea typeface="Calibri"/>
                <a:cs typeface="Vrinda"/>
              </a:rPr>
              <a:t>In an experiment similar to that shown in Fig. 3, samples of spent medium were collected at 0–1200 min after feeding of [</a:t>
            </a:r>
            <a:r>
              <a:rPr lang="en-GB" sz="1200" baseline="30000">
                <a:ea typeface="Calibri"/>
                <a:cs typeface="Vrinda"/>
              </a:rPr>
              <a:t>14</a:t>
            </a:r>
            <a:r>
              <a:rPr lang="en-GB" sz="1200">
                <a:ea typeface="Calibri"/>
                <a:cs typeface="Vrinda"/>
              </a:rPr>
              <a:t>C]glucose and subjected to paper chromatography in butan-1-ol/acetic acid/water 12:3:5 for 24 h. (a) </a:t>
            </a:r>
            <a:r>
              <a:rPr lang="en-GB" sz="1200" i="1">
                <a:ea typeface="Calibri"/>
                <a:cs typeface="Vrinda"/>
              </a:rPr>
              <a:t>Rosa</a:t>
            </a:r>
            <a:r>
              <a:rPr lang="en-GB" sz="1200">
                <a:ea typeface="Calibri"/>
                <a:cs typeface="Vrinda"/>
              </a:rPr>
              <a:t> (5-day culture); (b) arabidopsis (1-day culture). Horizontal pink line shows position of marker glucose (10–14 cm from origin). Most of the radioactivity co-migrated with free glucose, along with some minor product(s) with higher mobility. </a:t>
            </a:r>
            <a:endParaRPr lang="en-GB" sz="1200">
              <a:effectLst/>
              <a:latin typeface="Calibri"/>
              <a:ea typeface="Calibri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31429495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538734" y="920552"/>
            <a:ext cx="5780532" cy="4183380"/>
            <a:chOff x="538734" y="2861310"/>
            <a:chExt cx="5780532" cy="418338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38734" y="2861310"/>
              <a:ext cx="5780532" cy="418338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6200000">
              <a:off x="1277571" y="5265276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smtClean="0">
                  <a:solidFill>
                    <a:srgbClr val="FF0000"/>
                  </a:solidFill>
                  <a:latin typeface="Arial Narrow" panose="020B0606020202030204" pitchFamily="34" charset="0"/>
                </a:rPr>
                <a:t>Glucose</a:t>
              </a:r>
              <a:endParaRPr lang="en-GB" sz="1000">
                <a:solidFill>
                  <a:srgbClr val="FF0000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350583" y="4970392"/>
              <a:ext cx="9076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smtClean="0">
                  <a:solidFill>
                    <a:srgbClr val="008000"/>
                  </a:solidFill>
                  <a:latin typeface="Arial Narrow" panose="020B0606020202030204" pitchFamily="34" charset="0"/>
                </a:rPr>
                <a:t>Glucuronic acid</a:t>
              </a:r>
              <a:endParaRPr lang="en-GB" sz="1000">
                <a:solidFill>
                  <a:srgbClr val="008000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3226146" y="4716599"/>
              <a:ext cx="11769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smtClean="0">
                  <a:solidFill>
                    <a:srgbClr val="FF9900"/>
                  </a:solidFill>
                  <a:latin typeface="Arial Narrow" panose="020B0606020202030204" pitchFamily="34" charset="0"/>
                </a:rPr>
                <a:t>Glucose 6-phosphate</a:t>
              </a:r>
              <a:endParaRPr lang="en-GB" sz="1000">
                <a:solidFill>
                  <a:srgbClr val="FF9900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4421810" y="4868307"/>
              <a:ext cx="8018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UDP-glucose</a:t>
              </a:r>
              <a:endParaRPr lang="en-GB" sz="1000">
                <a:solidFill>
                  <a:srgbClr val="0000FF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5582890" y="4868367"/>
              <a:ext cx="6431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smtClean="0">
                  <a:solidFill>
                    <a:srgbClr val="FF00FF"/>
                  </a:solidFill>
                  <a:latin typeface="Arial Narrow" panose="020B0606020202030204" pitchFamily="34" charset="0"/>
                </a:rPr>
                <a:t>Orange G</a:t>
              </a:r>
              <a:endParaRPr lang="en-GB" sz="1000">
                <a:solidFill>
                  <a:srgbClr val="FF00FF"/>
                </a:solidFill>
                <a:latin typeface="Arial Narrow" panose="020B0606020202030204" pitchFamily="34" charset="0"/>
              </a:endParaRPr>
            </a:p>
          </p:txBody>
        </p:sp>
      </p:grpSp>
      <p:sp>
        <p:nvSpPr>
          <p:cNvPr id="11" name="Rectangle 10"/>
          <p:cNvSpPr/>
          <p:nvPr/>
        </p:nvSpPr>
        <p:spPr>
          <a:xfrm>
            <a:off x="1714500" y="6058098"/>
            <a:ext cx="3429000" cy="2279278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 b="1">
                <a:ea typeface="Calibri"/>
                <a:cs typeface="Vrinda"/>
              </a:rPr>
              <a:t>Fig. S3: Characterisation of the intermediary product, radiolabelled during exogenous feeding of [</a:t>
            </a:r>
            <a:r>
              <a:rPr lang="en-GB" sz="1200" b="1" baseline="30000">
                <a:ea typeface="Calibri"/>
                <a:cs typeface="Vrinda"/>
              </a:rPr>
              <a:t>14</a:t>
            </a:r>
            <a:r>
              <a:rPr lang="en-GB" sz="1200" b="1">
                <a:ea typeface="Calibri"/>
                <a:cs typeface="Vrinda"/>
              </a:rPr>
              <a:t>C]Glc and released from AIR by EPG.</a:t>
            </a:r>
            <a:r>
              <a:rPr lang="en-GB" sz="1200">
                <a:ea typeface="Calibri"/>
                <a:cs typeface="Vrinda"/>
              </a:rPr>
              <a:t> </a:t>
            </a:r>
            <a:endParaRPr lang="en-GB" sz="1200">
              <a:latin typeface="Calibri"/>
              <a:ea typeface="Calibri"/>
              <a:cs typeface="Vrinda"/>
            </a:endParaRPr>
          </a:p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>
                <a:ea typeface="Calibri"/>
                <a:cs typeface="Vrinda"/>
              </a:rPr>
              <a:t>The principal intermediary metabolite seen in Fig. 4 was eluted from the TLC plate and analysed by high-voltage paper electrophoresis in a buffer at pH 2.0 at 3.5 kV for 60 min. The positions of external markers are indicated by coloured horizontal lines.</a:t>
            </a:r>
            <a:endParaRPr lang="en-GB" sz="1200">
              <a:effectLst/>
              <a:latin typeface="Calibri"/>
              <a:ea typeface="Calibri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2438815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/>
          <p:cNvGrpSpPr>
            <a:grpSpLocks noChangeAspect="1"/>
          </p:cNvGrpSpPr>
          <p:nvPr/>
        </p:nvGrpSpPr>
        <p:grpSpPr>
          <a:xfrm>
            <a:off x="283226" y="992560"/>
            <a:ext cx="6295607" cy="4518102"/>
            <a:chOff x="116633" y="1499713"/>
            <a:chExt cx="6295607" cy="451810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4930" y="4047340"/>
              <a:ext cx="2700000" cy="197047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364930" y="2072680"/>
              <a:ext cx="2700000" cy="194862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245250" y="4047340"/>
              <a:ext cx="2700000" cy="1970475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3245250" y="2072680"/>
              <a:ext cx="2700000" cy="1948624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5969811" y="2824343"/>
              <a:ext cx="26289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di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969811" y="3209503"/>
              <a:ext cx="44242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mono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969811" y="4793679"/>
              <a:ext cx="26289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di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969811" y="5204945"/>
              <a:ext cx="44242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smtClean="0">
                  <a:latin typeface="Arial Narrow" panose="020B0606020202030204" pitchFamily="34" charset="0"/>
                  <a:cs typeface="Arial" pitchFamily="34" charset="0"/>
                </a:rPr>
                <a:t>monomer</a:t>
              </a:r>
              <a:endParaRPr lang="en-GB" sz="1000">
                <a:latin typeface="Arial Narrow" panose="020B0606020202030204" pitchFamily="34" charset="0"/>
                <a:cs typeface="Arial" pitchFamily="34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531588" y="1499713"/>
              <a:ext cx="2453874" cy="493944"/>
              <a:chOff x="3383226" y="451869"/>
              <a:chExt cx="2715417" cy="493944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3892335" y="451869"/>
                <a:ext cx="1759667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i="1" smtClean="0">
                    <a:latin typeface="Arial Narrow" panose="020B0606020202030204" pitchFamily="34" charset="0"/>
                    <a:cs typeface="Arial" pitchFamily="34" charset="0"/>
                  </a:rPr>
                  <a:t>Rosa </a:t>
                </a:r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incubation time (minutes)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1" name="AutoShape 4"/>
              <p:cNvSpPr>
                <a:spLocks/>
              </p:cNvSpPr>
              <p:nvPr/>
            </p:nvSpPr>
            <p:spPr bwMode="auto">
              <a:xfrm rot="16200000" flipH="1">
                <a:off x="4677844" y="-444937"/>
                <a:ext cx="183689" cy="2330004"/>
              </a:xfrm>
              <a:prstGeom prst="leftBrace">
                <a:avLst>
                  <a:gd name="adj1" fmla="val 97619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1100">
                  <a:latin typeface="Arial Narrow" panose="020B060602020203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383226" y="776536"/>
                <a:ext cx="1064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M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700428" y="776536"/>
                <a:ext cx="709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0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3988459" y="776536"/>
                <a:ext cx="709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4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541986" y="776536"/>
                <a:ext cx="141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16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822398" y="776536"/>
                <a:ext cx="141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24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5102811" y="776536"/>
                <a:ext cx="141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32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5362986" y="776536"/>
                <a:ext cx="212862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120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615540" y="776536"/>
                <a:ext cx="283817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1020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5992212" y="776536"/>
                <a:ext cx="1064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M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265659" y="776536"/>
                <a:ext cx="709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8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3344062" y="1499713"/>
              <a:ext cx="2453874" cy="493944"/>
              <a:chOff x="3383226" y="451869"/>
              <a:chExt cx="2715417" cy="493944"/>
            </a:xfrm>
          </p:grpSpPr>
          <p:sp>
            <p:nvSpPr>
              <p:cNvPr id="33" name="TextBox 32"/>
              <p:cNvSpPr txBox="1"/>
              <p:nvPr/>
            </p:nvSpPr>
            <p:spPr>
              <a:xfrm>
                <a:off x="3707855" y="451869"/>
                <a:ext cx="2128629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i="1" smtClean="0">
                    <a:latin typeface="Arial Narrow" panose="020B0606020202030204" pitchFamily="34" charset="0"/>
                    <a:cs typeface="Arial" pitchFamily="34" charset="0"/>
                  </a:rPr>
                  <a:t>Arabidopsis </a:t>
                </a:r>
                <a:r>
                  <a:rPr lang="en-GB" sz="1100">
                    <a:latin typeface="Arial Narrow" panose="020B0606020202030204" pitchFamily="34" charset="0"/>
                    <a:cs typeface="Arial" pitchFamily="34" charset="0"/>
                  </a:rPr>
                  <a:t>i</a:t>
                </a:r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ncubation time (minutes)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4" name="AutoShape 4"/>
              <p:cNvSpPr>
                <a:spLocks/>
              </p:cNvSpPr>
              <p:nvPr/>
            </p:nvSpPr>
            <p:spPr bwMode="auto">
              <a:xfrm rot="16200000" flipH="1">
                <a:off x="4677844" y="-444937"/>
                <a:ext cx="183689" cy="2330004"/>
              </a:xfrm>
              <a:prstGeom prst="leftBrace">
                <a:avLst>
                  <a:gd name="adj1" fmla="val 97619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1100">
                  <a:latin typeface="Arial Narrow" panose="020B060602020203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3383226" y="776536"/>
                <a:ext cx="1064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M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00428" y="776536"/>
                <a:ext cx="709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0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988459" y="776536"/>
                <a:ext cx="709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4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541986" y="776536"/>
                <a:ext cx="141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16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822398" y="776536"/>
                <a:ext cx="141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24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5102811" y="776536"/>
                <a:ext cx="141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32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5362986" y="776536"/>
                <a:ext cx="212862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120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5615540" y="776536"/>
                <a:ext cx="283817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1020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5992212" y="776536"/>
                <a:ext cx="1064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M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265659" y="776536"/>
                <a:ext cx="7095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GB" sz="1100" smtClean="0">
                    <a:latin typeface="Arial Narrow" panose="020B0606020202030204" pitchFamily="34" charset="0"/>
                    <a:cs typeface="Arial" pitchFamily="34" charset="0"/>
                  </a:rPr>
                  <a:t>8</a:t>
                </a:r>
                <a:endParaRPr lang="en-GB" sz="1100">
                  <a:latin typeface="Arial Narrow" panose="020B0606020202030204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5" name="TextBox 44"/>
            <p:cNvSpPr txBox="1"/>
            <p:nvPr/>
          </p:nvSpPr>
          <p:spPr>
            <a:xfrm rot="16200000">
              <a:off x="48024" y="3935841"/>
              <a:ext cx="352661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400" b="1" smtClean="0">
                  <a:latin typeface="Arial Narrow" panose="020B0606020202030204" pitchFamily="34" charset="0"/>
                  <a:cs typeface="Arial" pitchFamily="34" charset="0"/>
                </a:rPr>
                <a:t>Set 2</a:t>
              </a:r>
              <a:endParaRPr lang="en-GB" sz="1400" b="1">
                <a:latin typeface="Arial Narrow" panose="020B0606020202030204" pitchFamily="34" charset="0"/>
                <a:cs typeface="Arial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1714500" y="6475513"/>
            <a:ext cx="3429000" cy="142981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 b="1">
                <a:ea typeface="Calibri"/>
                <a:cs typeface="Vrinda"/>
              </a:rPr>
              <a:t>Fig. S4:</a:t>
            </a:r>
            <a:r>
              <a:rPr lang="en-GB" sz="1200">
                <a:ea typeface="Calibri"/>
                <a:cs typeface="Vrinda"/>
              </a:rPr>
              <a:t> </a:t>
            </a:r>
            <a:r>
              <a:rPr lang="en-GB" sz="1200" b="1">
                <a:ea typeface="Calibri"/>
                <a:cs typeface="Vrinda"/>
              </a:rPr>
              <a:t>Time-course of </a:t>
            </a:r>
            <a:r>
              <a:rPr lang="en-GB" sz="1200" b="1" baseline="30000">
                <a:ea typeface="Calibri"/>
                <a:cs typeface="Vrinda"/>
              </a:rPr>
              <a:t>14</a:t>
            </a:r>
            <a:r>
              <a:rPr lang="en-GB" sz="1200" b="1">
                <a:ea typeface="Calibri"/>
                <a:cs typeface="Vrinda"/>
              </a:rPr>
              <a:t>C-labelling of monomeric and dimeric RG-II domains: replicate.</a:t>
            </a:r>
            <a:endParaRPr lang="en-GB" sz="1200">
              <a:latin typeface="Calibri"/>
              <a:ea typeface="Calibri"/>
              <a:cs typeface="Vrinda"/>
            </a:endParaRPr>
          </a:p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200">
                <a:ea typeface="Calibri"/>
                <a:cs typeface="Vrinda"/>
              </a:rPr>
              <a:t>A repeat of the experiment shown in Fig. 6. These mini-cultures (set 2) were taken from independent standard cultures.</a:t>
            </a:r>
            <a:endParaRPr lang="en-GB" sz="1200">
              <a:effectLst/>
              <a:latin typeface="Calibri"/>
              <a:ea typeface="Calibri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1714048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349</Words>
  <Application>Microsoft Office PowerPoint</Application>
  <PresentationFormat>A4 Paper (210x297 mm)</PresentationFormat>
  <Paragraphs>7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 Narrow</vt:lpstr>
      <vt:lpstr>Calibri</vt:lpstr>
      <vt:lpstr>Vrind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Fry</dc:creator>
  <cp:lastModifiedBy>FRY Stephen</cp:lastModifiedBy>
  <cp:revision>28</cp:revision>
  <cp:lastPrinted>2022-01-11T00:08:15Z</cp:lastPrinted>
  <dcterms:created xsi:type="dcterms:W3CDTF">2015-05-28T18:40:23Z</dcterms:created>
  <dcterms:modified xsi:type="dcterms:W3CDTF">2022-07-18T17:12:04Z</dcterms:modified>
</cp:coreProperties>
</file>